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0" r:id="rId2"/>
  </p:sldIdLst>
  <p:sldSz cx="73152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im Tian" initials="TT" lastIdx="1" clrIdx="0">
    <p:extLst>
      <p:ext uri="{19B8F6BF-5375-455C-9EA6-DF929625EA0E}">
        <p15:presenceInfo xmlns:p15="http://schemas.microsoft.com/office/powerpoint/2012/main" userId="3d24e6a493cc3687" providerId="Windows Live"/>
      </p:ext>
    </p:extLst>
  </p:cmAuthor>
  <p:cmAuthor id="2" name="Anita Chong" initials="ASC" lastIdx="1" clrIdx="1">
    <p:extLst>
      <p:ext uri="{19B8F6BF-5375-455C-9EA6-DF929625EA0E}">
        <p15:presenceInfo xmlns:p15="http://schemas.microsoft.com/office/powerpoint/2012/main" userId="Anita Chong" providerId="None"/>
      </p:ext>
    </p:extLst>
  </p:cmAuthor>
  <p:cmAuthor id="3" name="Qiaomu Tian" initials="QT" lastIdx="1" clrIdx="2">
    <p:extLst>
      <p:ext uri="{19B8F6BF-5375-455C-9EA6-DF929625EA0E}">
        <p15:presenceInfo xmlns:p15="http://schemas.microsoft.com/office/powerpoint/2012/main" userId="Qiaomu Tia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3810" autoAdjust="0"/>
    <p:restoredTop sz="94660"/>
  </p:normalViewPr>
  <p:slideViewPr>
    <p:cSldViewPr snapToGrid="0">
      <p:cViewPr varScale="1">
        <p:scale>
          <a:sx n="91" d="100"/>
          <a:sy n="91" d="100"/>
        </p:scale>
        <p:origin x="3405" y="82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646133"/>
            <a:ext cx="6217920" cy="3501813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5282989"/>
            <a:ext cx="5486400" cy="2428451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285BA-15C8-4ADD-B1DC-7113C583633D}" type="datetimeFigureOut">
              <a:rPr lang="en-US" smtClean="0"/>
              <a:t>9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712B0-FBE2-4AE4-97A3-DFB76AABD9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96235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285BA-15C8-4ADD-B1DC-7113C583633D}" type="datetimeFigureOut">
              <a:rPr lang="en-US" smtClean="0"/>
              <a:t>9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712B0-FBE2-4AE4-97A3-DFB76AABD9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70565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535517"/>
            <a:ext cx="1577340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535517"/>
            <a:ext cx="4640580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285BA-15C8-4ADD-B1DC-7113C583633D}" type="datetimeFigureOut">
              <a:rPr lang="en-US" smtClean="0"/>
              <a:t>9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712B0-FBE2-4AE4-97A3-DFB76AABD9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15847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285BA-15C8-4ADD-B1DC-7113C583633D}" type="datetimeFigureOut">
              <a:rPr lang="en-US" smtClean="0"/>
              <a:t>9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712B0-FBE2-4AE4-97A3-DFB76AABD9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76202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507618"/>
            <a:ext cx="6309360" cy="4184014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731215"/>
            <a:ext cx="6309360" cy="2200274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285BA-15C8-4ADD-B1DC-7113C583633D}" type="datetimeFigureOut">
              <a:rPr lang="en-US" smtClean="0"/>
              <a:t>9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712B0-FBE2-4AE4-97A3-DFB76AABD9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42390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285BA-15C8-4ADD-B1DC-7113C583633D}" type="datetimeFigureOut">
              <a:rPr lang="en-US" smtClean="0"/>
              <a:t>9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712B0-FBE2-4AE4-97A3-DFB76AABD9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91177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535519"/>
            <a:ext cx="6309360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465706"/>
            <a:ext cx="3094672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674110"/>
            <a:ext cx="309467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465706"/>
            <a:ext cx="3109913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674110"/>
            <a:ext cx="3109913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285BA-15C8-4ADD-B1DC-7113C583633D}" type="datetimeFigureOut">
              <a:rPr lang="en-US" smtClean="0"/>
              <a:t>9/3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712B0-FBE2-4AE4-97A3-DFB76AABD9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56070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285BA-15C8-4ADD-B1DC-7113C583633D}" type="datetimeFigureOut">
              <a:rPr lang="en-US" smtClean="0"/>
              <a:t>9/3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712B0-FBE2-4AE4-97A3-DFB76AABD9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15693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285BA-15C8-4ADD-B1DC-7113C583633D}" type="datetimeFigureOut">
              <a:rPr lang="en-US" smtClean="0"/>
              <a:t>9/3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712B0-FBE2-4AE4-97A3-DFB76AABD9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98412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448226"/>
            <a:ext cx="3703320" cy="7147983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285BA-15C8-4ADD-B1DC-7113C583633D}" type="datetimeFigureOut">
              <a:rPr lang="en-US" smtClean="0"/>
              <a:t>9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712B0-FBE2-4AE4-97A3-DFB76AABD9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88808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448226"/>
            <a:ext cx="3703320" cy="7147983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285BA-15C8-4ADD-B1DC-7113C583633D}" type="datetimeFigureOut">
              <a:rPr lang="en-US" smtClean="0"/>
              <a:t>9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712B0-FBE2-4AE4-97A3-DFB76AABD9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98070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535519"/>
            <a:ext cx="6309360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677584"/>
            <a:ext cx="6309360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6285BA-15C8-4ADD-B1DC-7113C583633D}" type="datetimeFigureOut">
              <a:rPr lang="en-US" smtClean="0"/>
              <a:t>9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9322649"/>
            <a:ext cx="246888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B712B0-FBE2-4AE4-97A3-DFB76AABD9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92794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2">
            <a:extLst>
              <a:ext uri="{FF2B5EF4-FFF2-40B4-BE49-F238E27FC236}">
                <a16:creationId xmlns:a16="http://schemas.microsoft.com/office/drawing/2014/main" id="{F928DADA-9022-4111-B84D-50A3664E10C7}"/>
              </a:ext>
            </a:extLst>
          </p:cNvPr>
          <p:cNvGraphicFramePr>
            <a:graphicFrameLocks noGrp="1"/>
          </p:cNvGraphicFramePr>
          <p:nvPr/>
        </p:nvGraphicFramePr>
        <p:xfrm>
          <a:off x="99849" y="498331"/>
          <a:ext cx="7115502" cy="2565400"/>
        </p:xfrm>
        <a:graphic>
          <a:graphicData uri="http://schemas.openxmlformats.org/drawingml/2006/table">
            <a:tbl>
              <a:tblPr firstRow="1" bandRow="1">
                <a:tableStyleId>{8EC20E35-A176-4012-BC5E-935CFFF8708E}</a:tableStyleId>
              </a:tblPr>
              <a:tblGrid>
                <a:gridCol w="1107407">
                  <a:extLst>
                    <a:ext uri="{9D8B030D-6E8A-4147-A177-3AD203B41FA5}">
                      <a16:colId xmlns:a16="http://schemas.microsoft.com/office/drawing/2014/main" val="3325195841"/>
                    </a:ext>
                  </a:extLst>
                </a:gridCol>
                <a:gridCol w="908858">
                  <a:extLst>
                    <a:ext uri="{9D8B030D-6E8A-4147-A177-3AD203B41FA5}">
                      <a16:colId xmlns:a16="http://schemas.microsoft.com/office/drawing/2014/main" val="254642612"/>
                    </a:ext>
                  </a:extLst>
                </a:gridCol>
                <a:gridCol w="1283982">
                  <a:extLst>
                    <a:ext uri="{9D8B030D-6E8A-4147-A177-3AD203B41FA5}">
                      <a16:colId xmlns:a16="http://schemas.microsoft.com/office/drawing/2014/main" val="59311040"/>
                    </a:ext>
                  </a:extLst>
                </a:gridCol>
                <a:gridCol w="1349242">
                  <a:extLst>
                    <a:ext uri="{9D8B030D-6E8A-4147-A177-3AD203B41FA5}">
                      <a16:colId xmlns:a16="http://schemas.microsoft.com/office/drawing/2014/main" val="182509170"/>
                    </a:ext>
                  </a:extLst>
                </a:gridCol>
                <a:gridCol w="1917469">
                  <a:extLst>
                    <a:ext uri="{9D8B030D-6E8A-4147-A177-3AD203B41FA5}">
                      <a16:colId xmlns:a16="http://schemas.microsoft.com/office/drawing/2014/main" val="2743666425"/>
                    </a:ext>
                  </a:extLst>
                </a:gridCol>
                <a:gridCol w="548544">
                  <a:extLst>
                    <a:ext uri="{9D8B030D-6E8A-4147-A177-3AD203B41FA5}">
                      <a16:colId xmlns:a16="http://schemas.microsoft.com/office/drawing/2014/main" val="1980839223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ganoid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20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atient #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tation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ig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juvant Therap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60612501"/>
                  </a:ext>
                </a:extLst>
              </a:tr>
              <a:tr h="174547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12-0118-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RAS_G12R</a:t>
                      </a:r>
                    </a:p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P53_F134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X (derived from PDAC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emcitabine; FOLFIRINOX</a:t>
                      </a:r>
                      <a:endParaRPr 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200" dirty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17492449"/>
                  </a:ext>
                </a:extLst>
              </a:tr>
              <a:tr h="178665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12-0118-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RAS_G12R</a:t>
                      </a:r>
                    </a:p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P53_F270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X (derived from PDAC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73152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_tradnl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OLFIRINOX (no </a:t>
                      </a:r>
                      <a:r>
                        <a:rPr lang="es-ES_tradnl" sz="12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rinotecan</a:t>
                      </a:r>
                      <a:r>
                        <a:rPr lang="es-ES_tradnl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); </a:t>
                      </a:r>
                      <a:r>
                        <a:rPr lang="es-ES_tradnl" sz="12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emcitabine</a:t>
                      </a:r>
                      <a:r>
                        <a:rPr lang="es-ES_tradnl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/</a:t>
                      </a:r>
                      <a:r>
                        <a:rPr lang="es-ES_tradnl" sz="12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braxane</a:t>
                      </a:r>
                      <a:endParaRPr lang="en-US" sz="1050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73152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5613522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73152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12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73152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  <a:p>
                      <a:pPr algn="ctr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RAS_G12D</a:t>
                      </a:r>
                    </a:p>
                    <a:p>
                      <a:pPr marL="0" marR="0" lvl="0" indent="0" algn="ctr" defTabSz="73152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P53_G245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rimary(PDAC)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emcitabine; Gemcitabine/Abraxane</a:t>
                      </a:r>
                      <a:endParaRPr lang="en-US" sz="1050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200" dirty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5059994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73152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11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RAS_G12D</a:t>
                      </a:r>
                    </a:p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P53-chr17_7578176_C-&gt;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73152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rimary(PDAC)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emcitabine; Gemcitabine/Abraxane</a:t>
                      </a:r>
                      <a:endParaRPr lang="en-US" sz="1050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200" dirty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18268837"/>
                  </a:ext>
                </a:extLst>
              </a:tr>
            </a:tbl>
          </a:graphicData>
        </a:graphic>
      </p:graphicFrame>
      <p:sp>
        <p:nvSpPr>
          <p:cNvPr id="5" name="Rectangle 4">
            <a:extLst>
              <a:ext uri="{FF2B5EF4-FFF2-40B4-BE49-F238E27FC236}">
                <a16:creationId xmlns:a16="http://schemas.microsoft.com/office/drawing/2014/main" id="{E6639A24-1BD6-4E27-A1C3-4AB95E1121D5}"/>
              </a:ext>
            </a:extLst>
          </p:cNvPr>
          <p:cNvSpPr/>
          <p:nvPr/>
        </p:nvSpPr>
        <p:spPr>
          <a:xfrm>
            <a:off x="174596" y="3224395"/>
            <a:ext cx="696600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4-source data1. Essential information on the pancreatic tumor organoids used in this study. Details of organoids from Patient# 1, 2, 6 and 7 are provided in reference 39 (Romero-Calvo et al., Molecular Cancer Research 2019)  </a:t>
            </a:r>
          </a:p>
        </p:txBody>
      </p:sp>
    </p:spTree>
    <p:extLst>
      <p:ext uri="{BB962C8B-B14F-4D97-AF65-F5344CB8AC3E}">
        <p14:creationId xmlns:p14="http://schemas.microsoft.com/office/powerpoint/2010/main" val="39715718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02</TotalTime>
  <Words>131</Words>
  <Application>Microsoft Office PowerPoint</Application>
  <PresentationFormat>Custom</PresentationFormat>
  <Paragraphs>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Qiaomu Tian</dc:creator>
  <cp:lastModifiedBy>Qiaomu Tian</cp:lastModifiedBy>
  <cp:revision>187</cp:revision>
  <dcterms:created xsi:type="dcterms:W3CDTF">2020-03-31T19:58:52Z</dcterms:created>
  <dcterms:modified xsi:type="dcterms:W3CDTF">2023-09-30T20:43:28Z</dcterms:modified>
</cp:coreProperties>
</file>